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43511788" cy="216185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026" autoAdjust="0"/>
  </p:normalViewPr>
  <p:slideViewPr>
    <p:cSldViewPr snapToGrid="0">
      <p:cViewPr varScale="1">
        <p:scale>
          <a:sx n="34" d="100"/>
          <a:sy n="34" d="100"/>
        </p:scale>
        <p:origin x="228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38974" y="3538041"/>
            <a:ext cx="32633841" cy="7526467"/>
          </a:xfrm>
        </p:spPr>
        <p:txBody>
          <a:bodyPr anchor="b"/>
          <a:lstStyle>
            <a:lvl1pPr algn="ctr">
              <a:defRPr sz="189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38974" y="11354758"/>
            <a:ext cx="32633841" cy="5219483"/>
          </a:xfrm>
        </p:spPr>
        <p:txBody>
          <a:bodyPr/>
          <a:lstStyle>
            <a:lvl1pPr marL="0" indent="0" algn="ctr">
              <a:buNone/>
              <a:defRPr sz="7566"/>
            </a:lvl1pPr>
            <a:lvl2pPr marL="1441232" indent="0" algn="ctr">
              <a:buNone/>
              <a:defRPr sz="6305"/>
            </a:lvl2pPr>
            <a:lvl3pPr marL="2882463" indent="0" algn="ctr">
              <a:buNone/>
              <a:defRPr sz="5674"/>
            </a:lvl3pPr>
            <a:lvl4pPr marL="4323695" indent="0" algn="ctr">
              <a:buNone/>
              <a:defRPr sz="5044"/>
            </a:lvl4pPr>
            <a:lvl5pPr marL="5764926" indent="0" algn="ctr">
              <a:buNone/>
              <a:defRPr sz="5044"/>
            </a:lvl5pPr>
            <a:lvl6pPr marL="7206158" indent="0" algn="ctr">
              <a:buNone/>
              <a:defRPr sz="5044"/>
            </a:lvl6pPr>
            <a:lvl7pPr marL="8647389" indent="0" algn="ctr">
              <a:buNone/>
              <a:defRPr sz="5044"/>
            </a:lvl7pPr>
            <a:lvl8pPr marL="10088621" indent="0" algn="ctr">
              <a:buNone/>
              <a:defRPr sz="5044"/>
            </a:lvl8pPr>
            <a:lvl9pPr marL="11529852" indent="0" algn="ctr">
              <a:buNone/>
              <a:defRPr sz="504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556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30872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1138123" y="1150989"/>
            <a:ext cx="9382229" cy="1832074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91435" y="1150989"/>
            <a:ext cx="27602791" cy="1832074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2099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32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68773" y="5389634"/>
            <a:ext cx="37528917" cy="8992725"/>
          </a:xfrm>
        </p:spPr>
        <p:txBody>
          <a:bodyPr anchor="b"/>
          <a:lstStyle>
            <a:lvl1pPr>
              <a:defRPr sz="1891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68773" y="14467434"/>
            <a:ext cx="37528917" cy="4729062"/>
          </a:xfrm>
        </p:spPr>
        <p:txBody>
          <a:bodyPr/>
          <a:lstStyle>
            <a:lvl1pPr marL="0" indent="0">
              <a:buNone/>
              <a:defRPr sz="7566">
                <a:solidFill>
                  <a:schemeClr val="tx1">
                    <a:tint val="75000"/>
                  </a:schemeClr>
                </a:solidFill>
              </a:defRPr>
            </a:lvl1pPr>
            <a:lvl2pPr marL="1441232" indent="0">
              <a:buNone/>
              <a:defRPr sz="6305">
                <a:solidFill>
                  <a:schemeClr val="tx1">
                    <a:tint val="75000"/>
                  </a:schemeClr>
                </a:solidFill>
              </a:defRPr>
            </a:lvl2pPr>
            <a:lvl3pPr marL="2882463" indent="0">
              <a:buNone/>
              <a:defRPr sz="5674">
                <a:solidFill>
                  <a:schemeClr val="tx1">
                    <a:tint val="75000"/>
                  </a:schemeClr>
                </a:solidFill>
              </a:defRPr>
            </a:lvl3pPr>
            <a:lvl4pPr marL="4323695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4pPr>
            <a:lvl5pPr marL="5764926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5pPr>
            <a:lvl6pPr marL="7206158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6pPr>
            <a:lvl7pPr marL="8647389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7pPr>
            <a:lvl8pPr marL="10088621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8pPr>
            <a:lvl9pPr marL="11529852" indent="0">
              <a:buNone/>
              <a:defRPr sz="50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2809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91435" y="5754945"/>
            <a:ext cx="18492510" cy="1371678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27843" y="5754945"/>
            <a:ext cx="18492510" cy="1371678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99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97103" y="1150990"/>
            <a:ext cx="37528917" cy="417859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97105" y="5299555"/>
            <a:ext cx="18407524" cy="2597230"/>
          </a:xfrm>
        </p:spPr>
        <p:txBody>
          <a:bodyPr anchor="b"/>
          <a:lstStyle>
            <a:lvl1pPr marL="0" indent="0">
              <a:buNone/>
              <a:defRPr sz="7566" b="1"/>
            </a:lvl1pPr>
            <a:lvl2pPr marL="1441232" indent="0">
              <a:buNone/>
              <a:defRPr sz="6305" b="1"/>
            </a:lvl2pPr>
            <a:lvl3pPr marL="2882463" indent="0">
              <a:buNone/>
              <a:defRPr sz="5674" b="1"/>
            </a:lvl3pPr>
            <a:lvl4pPr marL="4323695" indent="0">
              <a:buNone/>
              <a:defRPr sz="5044" b="1"/>
            </a:lvl4pPr>
            <a:lvl5pPr marL="5764926" indent="0">
              <a:buNone/>
              <a:defRPr sz="5044" b="1"/>
            </a:lvl5pPr>
            <a:lvl6pPr marL="7206158" indent="0">
              <a:buNone/>
              <a:defRPr sz="5044" b="1"/>
            </a:lvl6pPr>
            <a:lvl7pPr marL="8647389" indent="0">
              <a:buNone/>
              <a:defRPr sz="5044" b="1"/>
            </a:lvl7pPr>
            <a:lvl8pPr marL="10088621" indent="0">
              <a:buNone/>
              <a:defRPr sz="5044" b="1"/>
            </a:lvl8pPr>
            <a:lvl9pPr marL="11529852" indent="0">
              <a:buNone/>
              <a:defRPr sz="50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97105" y="7896785"/>
            <a:ext cx="18407524" cy="1161498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2027843" y="5299555"/>
            <a:ext cx="18498177" cy="2597230"/>
          </a:xfrm>
        </p:spPr>
        <p:txBody>
          <a:bodyPr anchor="b"/>
          <a:lstStyle>
            <a:lvl1pPr marL="0" indent="0">
              <a:buNone/>
              <a:defRPr sz="7566" b="1"/>
            </a:lvl1pPr>
            <a:lvl2pPr marL="1441232" indent="0">
              <a:buNone/>
              <a:defRPr sz="6305" b="1"/>
            </a:lvl2pPr>
            <a:lvl3pPr marL="2882463" indent="0">
              <a:buNone/>
              <a:defRPr sz="5674" b="1"/>
            </a:lvl3pPr>
            <a:lvl4pPr marL="4323695" indent="0">
              <a:buNone/>
              <a:defRPr sz="5044" b="1"/>
            </a:lvl4pPr>
            <a:lvl5pPr marL="5764926" indent="0">
              <a:buNone/>
              <a:defRPr sz="5044" b="1"/>
            </a:lvl5pPr>
            <a:lvl6pPr marL="7206158" indent="0">
              <a:buNone/>
              <a:defRPr sz="5044" b="1"/>
            </a:lvl6pPr>
            <a:lvl7pPr marL="8647389" indent="0">
              <a:buNone/>
              <a:defRPr sz="5044" b="1"/>
            </a:lvl7pPr>
            <a:lvl8pPr marL="10088621" indent="0">
              <a:buNone/>
              <a:defRPr sz="5044" b="1"/>
            </a:lvl8pPr>
            <a:lvl9pPr marL="11529852" indent="0">
              <a:buNone/>
              <a:defRPr sz="50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2027843" y="7896785"/>
            <a:ext cx="18498177" cy="1161498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6704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89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80454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97105" y="1441238"/>
            <a:ext cx="14033683" cy="5044334"/>
          </a:xfrm>
        </p:spPr>
        <p:txBody>
          <a:bodyPr anchor="b"/>
          <a:lstStyle>
            <a:lvl1pPr>
              <a:defRPr sz="10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498177" y="3112676"/>
            <a:ext cx="22027843" cy="15363200"/>
          </a:xfrm>
        </p:spPr>
        <p:txBody>
          <a:bodyPr/>
          <a:lstStyle>
            <a:lvl1pPr>
              <a:defRPr sz="10087"/>
            </a:lvl1pPr>
            <a:lvl2pPr>
              <a:defRPr sz="8826"/>
            </a:lvl2pPr>
            <a:lvl3pPr>
              <a:defRPr sz="7566"/>
            </a:lvl3pPr>
            <a:lvl4pPr>
              <a:defRPr sz="6305"/>
            </a:lvl4pPr>
            <a:lvl5pPr>
              <a:defRPr sz="6305"/>
            </a:lvl5pPr>
            <a:lvl6pPr>
              <a:defRPr sz="6305"/>
            </a:lvl6pPr>
            <a:lvl7pPr>
              <a:defRPr sz="6305"/>
            </a:lvl7pPr>
            <a:lvl8pPr>
              <a:defRPr sz="6305"/>
            </a:lvl8pPr>
            <a:lvl9pPr>
              <a:defRPr sz="630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97105" y="6485573"/>
            <a:ext cx="14033683" cy="12015325"/>
          </a:xfrm>
        </p:spPr>
        <p:txBody>
          <a:bodyPr/>
          <a:lstStyle>
            <a:lvl1pPr marL="0" indent="0">
              <a:buNone/>
              <a:defRPr sz="5044"/>
            </a:lvl1pPr>
            <a:lvl2pPr marL="1441232" indent="0">
              <a:buNone/>
              <a:defRPr sz="4413"/>
            </a:lvl2pPr>
            <a:lvl3pPr marL="2882463" indent="0">
              <a:buNone/>
              <a:defRPr sz="3783"/>
            </a:lvl3pPr>
            <a:lvl4pPr marL="4323695" indent="0">
              <a:buNone/>
              <a:defRPr sz="3152"/>
            </a:lvl4pPr>
            <a:lvl5pPr marL="5764926" indent="0">
              <a:buNone/>
              <a:defRPr sz="3152"/>
            </a:lvl5pPr>
            <a:lvl6pPr marL="7206158" indent="0">
              <a:buNone/>
              <a:defRPr sz="3152"/>
            </a:lvl6pPr>
            <a:lvl7pPr marL="8647389" indent="0">
              <a:buNone/>
              <a:defRPr sz="3152"/>
            </a:lvl7pPr>
            <a:lvl8pPr marL="10088621" indent="0">
              <a:buNone/>
              <a:defRPr sz="3152"/>
            </a:lvl8pPr>
            <a:lvl9pPr marL="11529852" indent="0">
              <a:buNone/>
              <a:defRPr sz="315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76608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97105" y="1441238"/>
            <a:ext cx="14033683" cy="5044334"/>
          </a:xfrm>
        </p:spPr>
        <p:txBody>
          <a:bodyPr anchor="b"/>
          <a:lstStyle>
            <a:lvl1pPr>
              <a:defRPr sz="10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498177" y="3112676"/>
            <a:ext cx="22027843" cy="15363200"/>
          </a:xfrm>
        </p:spPr>
        <p:txBody>
          <a:bodyPr anchor="t"/>
          <a:lstStyle>
            <a:lvl1pPr marL="0" indent="0">
              <a:buNone/>
              <a:defRPr sz="10087"/>
            </a:lvl1pPr>
            <a:lvl2pPr marL="1441232" indent="0">
              <a:buNone/>
              <a:defRPr sz="8826"/>
            </a:lvl2pPr>
            <a:lvl3pPr marL="2882463" indent="0">
              <a:buNone/>
              <a:defRPr sz="7566"/>
            </a:lvl3pPr>
            <a:lvl4pPr marL="4323695" indent="0">
              <a:buNone/>
              <a:defRPr sz="6305"/>
            </a:lvl4pPr>
            <a:lvl5pPr marL="5764926" indent="0">
              <a:buNone/>
              <a:defRPr sz="6305"/>
            </a:lvl5pPr>
            <a:lvl6pPr marL="7206158" indent="0">
              <a:buNone/>
              <a:defRPr sz="6305"/>
            </a:lvl6pPr>
            <a:lvl7pPr marL="8647389" indent="0">
              <a:buNone/>
              <a:defRPr sz="6305"/>
            </a:lvl7pPr>
            <a:lvl8pPr marL="10088621" indent="0">
              <a:buNone/>
              <a:defRPr sz="6305"/>
            </a:lvl8pPr>
            <a:lvl9pPr marL="11529852" indent="0">
              <a:buNone/>
              <a:defRPr sz="630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97105" y="6485573"/>
            <a:ext cx="14033683" cy="12015325"/>
          </a:xfrm>
        </p:spPr>
        <p:txBody>
          <a:bodyPr/>
          <a:lstStyle>
            <a:lvl1pPr marL="0" indent="0">
              <a:buNone/>
              <a:defRPr sz="5044"/>
            </a:lvl1pPr>
            <a:lvl2pPr marL="1441232" indent="0">
              <a:buNone/>
              <a:defRPr sz="4413"/>
            </a:lvl2pPr>
            <a:lvl3pPr marL="2882463" indent="0">
              <a:buNone/>
              <a:defRPr sz="3783"/>
            </a:lvl3pPr>
            <a:lvl4pPr marL="4323695" indent="0">
              <a:buNone/>
              <a:defRPr sz="3152"/>
            </a:lvl4pPr>
            <a:lvl5pPr marL="5764926" indent="0">
              <a:buNone/>
              <a:defRPr sz="3152"/>
            </a:lvl5pPr>
            <a:lvl6pPr marL="7206158" indent="0">
              <a:buNone/>
              <a:defRPr sz="3152"/>
            </a:lvl6pPr>
            <a:lvl7pPr marL="8647389" indent="0">
              <a:buNone/>
              <a:defRPr sz="3152"/>
            </a:lvl7pPr>
            <a:lvl8pPr marL="10088621" indent="0">
              <a:buNone/>
              <a:defRPr sz="3152"/>
            </a:lvl8pPr>
            <a:lvl9pPr marL="11529852" indent="0">
              <a:buNone/>
              <a:defRPr sz="315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9059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91436" y="1150990"/>
            <a:ext cx="37528917" cy="4178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91436" y="5754945"/>
            <a:ext cx="37528917" cy="137167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91436" y="20037218"/>
            <a:ext cx="9790152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AACC1-4A5E-473E-B970-51C35F070852}" type="datetimeFigureOut">
              <a:rPr lang="zh-CN" altLang="en-US" smtClean="0"/>
              <a:t>2025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413280" y="20037218"/>
            <a:ext cx="14685228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730200" y="20037218"/>
            <a:ext cx="9790152" cy="11509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31EA3-82A1-487E-B0D5-E91DB4D4562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320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882463" rtl="0" eaLnBrk="1" latinLnBrk="0" hangingPunct="1">
        <a:lnSpc>
          <a:spcPct val="90000"/>
        </a:lnSpc>
        <a:spcBef>
          <a:spcPct val="0"/>
        </a:spcBef>
        <a:buNone/>
        <a:defRPr sz="1387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616" indent="-720616" algn="l" defTabSz="2882463" rtl="0" eaLnBrk="1" latinLnBrk="0" hangingPunct="1">
        <a:lnSpc>
          <a:spcPct val="90000"/>
        </a:lnSpc>
        <a:spcBef>
          <a:spcPts val="3152"/>
        </a:spcBef>
        <a:buFont typeface="Arial" panose="020B0604020202020204" pitchFamily="34" charset="0"/>
        <a:buChar char="•"/>
        <a:defRPr sz="8826" kern="1200">
          <a:solidFill>
            <a:schemeClr val="tx1"/>
          </a:solidFill>
          <a:latin typeface="+mn-lt"/>
          <a:ea typeface="+mn-ea"/>
          <a:cs typeface="+mn-cs"/>
        </a:defRPr>
      </a:lvl1pPr>
      <a:lvl2pPr marL="2161847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7566" kern="1200">
          <a:solidFill>
            <a:schemeClr val="tx1"/>
          </a:solidFill>
          <a:latin typeface="+mn-lt"/>
          <a:ea typeface="+mn-ea"/>
          <a:cs typeface="+mn-cs"/>
        </a:defRPr>
      </a:lvl2pPr>
      <a:lvl3pPr marL="3603079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6305" kern="1200">
          <a:solidFill>
            <a:schemeClr val="tx1"/>
          </a:solidFill>
          <a:latin typeface="+mn-lt"/>
          <a:ea typeface="+mn-ea"/>
          <a:cs typeface="+mn-cs"/>
        </a:defRPr>
      </a:lvl3pPr>
      <a:lvl4pPr marL="5044310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4pPr>
      <a:lvl5pPr marL="6485542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5pPr>
      <a:lvl6pPr marL="7926774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6pPr>
      <a:lvl7pPr marL="9368005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7pPr>
      <a:lvl8pPr marL="10809237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8pPr>
      <a:lvl9pPr marL="12250468" indent="-720616" algn="l" defTabSz="2882463" rtl="0" eaLnBrk="1" latinLnBrk="0" hangingPunct="1">
        <a:lnSpc>
          <a:spcPct val="90000"/>
        </a:lnSpc>
        <a:spcBef>
          <a:spcPts val="1576"/>
        </a:spcBef>
        <a:buFont typeface="Arial" panose="020B0604020202020204" pitchFamily="34" charset="0"/>
        <a:buChar char="•"/>
        <a:defRPr sz="567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1pPr>
      <a:lvl2pPr marL="1441232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2pPr>
      <a:lvl3pPr marL="2882463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3pPr>
      <a:lvl4pPr marL="4323695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4pPr>
      <a:lvl5pPr marL="5764926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5pPr>
      <a:lvl6pPr marL="7206158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6pPr>
      <a:lvl7pPr marL="8647389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7pPr>
      <a:lvl8pPr marL="10088621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8pPr>
      <a:lvl9pPr marL="11529852" algn="l" defTabSz="2882463" rtl="0" eaLnBrk="1" latinLnBrk="0" hangingPunct="1">
        <a:defRPr sz="567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jp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>
            <a:extLst>
              <a:ext uri="{FF2B5EF4-FFF2-40B4-BE49-F238E27FC236}">
                <a16:creationId xmlns:a16="http://schemas.microsoft.com/office/drawing/2014/main" id="{1C239B24-F8FD-E770-19EB-10E2A8969FFD}"/>
              </a:ext>
            </a:extLst>
          </p:cNvPr>
          <p:cNvGrpSpPr/>
          <p:nvPr/>
        </p:nvGrpSpPr>
        <p:grpSpPr>
          <a:xfrm>
            <a:off x="6720942" y="0"/>
            <a:ext cx="19789881" cy="21122539"/>
            <a:chOff x="10467033" y="-862195"/>
            <a:chExt cx="19789881" cy="21122539"/>
          </a:xfrm>
        </p:grpSpPr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7F0C9DC0-6748-B11C-196D-E60E364C28DE}"/>
                </a:ext>
              </a:extLst>
            </p:cNvPr>
            <p:cNvGrpSpPr/>
            <p:nvPr/>
          </p:nvGrpSpPr>
          <p:grpSpPr>
            <a:xfrm>
              <a:off x="11653946" y="5536155"/>
              <a:ext cx="17487787" cy="2473503"/>
              <a:chOff x="3025372" y="7280096"/>
              <a:chExt cx="17487787" cy="2473503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BDE8655-3D84-186B-D729-4CBF7A006A2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25373" y="7280096"/>
                <a:ext cx="17487786" cy="2473503"/>
              </a:xfrm>
              <a:prstGeom prst="rect">
                <a:avLst/>
              </a:prstGeom>
            </p:spPr>
          </p:pic>
          <p:sp>
            <p:nvSpPr>
              <p:cNvPr id="6" name="左大括号 5">
                <a:extLst>
                  <a:ext uri="{FF2B5EF4-FFF2-40B4-BE49-F238E27FC236}">
                    <a16:creationId xmlns:a16="http://schemas.microsoft.com/office/drawing/2014/main" id="{E1C32E5F-D8CD-C6FA-52E5-3B0CA0E262E6}"/>
                  </a:ext>
                </a:extLst>
              </p:cNvPr>
              <p:cNvSpPr/>
              <p:nvPr/>
            </p:nvSpPr>
            <p:spPr>
              <a:xfrm rot="5400000">
                <a:off x="6151866" y="4945697"/>
                <a:ext cx="309810" cy="6562797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1F9A644E-4E01-82EF-14E3-19B65EC7A56E}"/>
                  </a:ext>
                </a:extLst>
              </p:cNvPr>
              <p:cNvSpPr txBox="1"/>
              <p:nvPr/>
            </p:nvSpPr>
            <p:spPr>
              <a:xfrm>
                <a:off x="5615715" y="7658224"/>
                <a:ext cx="138211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887bp</a:t>
                </a:r>
                <a:endParaRPr lang="zh-CN" altLang="en-US" sz="2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左大括号 7">
                <a:extLst>
                  <a:ext uri="{FF2B5EF4-FFF2-40B4-BE49-F238E27FC236}">
                    <a16:creationId xmlns:a16="http://schemas.microsoft.com/office/drawing/2014/main" id="{6618D928-78E9-DA44-7948-2ABD53A7D196}"/>
                  </a:ext>
                </a:extLst>
              </p:cNvPr>
              <p:cNvSpPr/>
              <p:nvPr/>
            </p:nvSpPr>
            <p:spPr>
              <a:xfrm rot="5400000">
                <a:off x="19118069" y="7148514"/>
                <a:ext cx="324989" cy="2172343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7212BEAA-7802-FB23-9CA2-AF56F937046A}"/>
                  </a:ext>
                </a:extLst>
              </p:cNvPr>
              <p:cNvSpPr txBox="1"/>
              <p:nvPr/>
            </p:nvSpPr>
            <p:spPr>
              <a:xfrm>
                <a:off x="18691281" y="7658223"/>
                <a:ext cx="1555907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9bp</a:t>
                </a:r>
                <a:endParaRPr lang="zh-CN" altLang="en-US" sz="2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597A262E-C1B3-4B2A-8DA7-1F231AD768A3}"/>
                  </a:ext>
                </a:extLst>
              </p:cNvPr>
              <p:cNvSpPr/>
              <p:nvPr/>
            </p:nvSpPr>
            <p:spPr>
              <a:xfrm>
                <a:off x="11697533" y="7733073"/>
                <a:ext cx="816578" cy="174366"/>
              </a:xfrm>
              <a:prstGeom prst="rect">
                <a:avLst/>
              </a:prstGeom>
              <a:solidFill>
                <a:srgbClr val="E7FF09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A2BFD5E9-DFA6-D1FC-C45C-52D8D75B0AD9}"/>
                  </a:ext>
                </a:extLst>
              </p:cNvPr>
              <p:cNvSpPr txBox="1"/>
              <p:nvPr/>
            </p:nvSpPr>
            <p:spPr>
              <a:xfrm>
                <a:off x="12563572" y="7548964"/>
                <a:ext cx="2226515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o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2412547-D2E9-8171-3225-82105432A6DF}"/>
                  </a:ext>
                </a:extLst>
              </p:cNvPr>
              <p:cNvSpPr txBox="1"/>
              <p:nvPr/>
            </p:nvSpPr>
            <p:spPr>
              <a:xfrm>
                <a:off x="14232903" y="7548969"/>
                <a:ext cx="2742287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" name="直接连接符 12">
                <a:extLst>
                  <a:ext uri="{FF2B5EF4-FFF2-40B4-BE49-F238E27FC236}">
                    <a16:creationId xmlns:a16="http://schemas.microsoft.com/office/drawing/2014/main" id="{5D619807-4A38-29BA-476C-CF171352140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13546711" y="7848100"/>
                <a:ext cx="736384" cy="4837"/>
              </a:xfrm>
              <a:prstGeom prst="line">
                <a:avLst/>
              </a:prstGeom>
              <a:ln w="25400">
                <a:solidFill>
                  <a:srgbClr val="A1BBE9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37BBE6AC-DA13-D491-8ECA-85AA075E2354}"/>
                </a:ext>
              </a:extLst>
            </p:cNvPr>
            <p:cNvGrpSpPr/>
            <p:nvPr/>
          </p:nvGrpSpPr>
          <p:grpSpPr>
            <a:xfrm>
              <a:off x="11174742" y="-862195"/>
              <a:ext cx="19082172" cy="7200000"/>
              <a:chOff x="11174742" y="-862195"/>
              <a:chExt cx="19082172" cy="7200000"/>
            </a:xfrm>
          </p:grpSpPr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53381F96-BE04-8DCF-E7EF-3183DC31E1F4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11174742" y="-862195"/>
                <a:ext cx="19082172" cy="7200000"/>
                <a:chOff x="-507564" y="-543393"/>
                <a:chExt cx="24697061" cy="9318585"/>
              </a:xfrm>
            </p:grpSpPr>
            <p:pic>
              <p:nvPicPr>
                <p:cNvPr id="19" name="图片 18">
                  <a:extLst>
                    <a:ext uri="{FF2B5EF4-FFF2-40B4-BE49-F238E27FC236}">
                      <a16:creationId xmlns:a16="http://schemas.microsoft.com/office/drawing/2014/main" id="{4027595D-3A8F-AD67-4DFD-ECE7A865136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-507564" y="0"/>
                  <a:ext cx="10841736" cy="8775192"/>
                </a:xfrm>
                <a:prstGeom prst="rect">
                  <a:avLst/>
                </a:prstGeom>
              </p:spPr>
            </p:pic>
            <p:pic>
              <p:nvPicPr>
                <p:cNvPr id="20" name="图片 19">
                  <a:extLst>
                    <a:ext uri="{FF2B5EF4-FFF2-40B4-BE49-F238E27FC236}">
                      <a16:creationId xmlns:a16="http://schemas.microsoft.com/office/drawing/2014/main" id="{786AE7BA-F606-2B72-1CB9-8B23531045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320583" y="-543393"/>
                  <a:ext cx="10841736" cy="8763000"/>
                </a:xfrm>
                <a:prstGeom prst="rect">
                  <a:avLst/>
                </a:prstGeom>
              </p:spPr>
            </p:pic>
            <p:pic>
              <p:nvPicPr>
                <p:cNvPr id="21" name="图片 20">
                  <a:extLst>
                    <a:ext uri="{FF2B5EF4-FFF2-40B4-BE49-F238E27FC236}">
                      <a16:creationId xmlns:a16="http://schemas.microsoft.com/office/drawing/2014/main" id="{C1992B88-E776-F14C-7DCD-1423E64E60F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347761" y="-543393"/>
                  <a:ext cx="10841736" cy="8763000"/>
                </a:xfrm>
                <a:prstGeom prst="rect">
                  <a:avLst/>
                </a:prstGeom>
              </p:spPr>
            </p:pic>
          </p:grp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FCBE55B8-006E-798F-552D-EE85CA13EC04}"/>
                  </a:ext>
                </a:extLst>
              </p:cNvPr>
              <p:cNvSpPr txBox="1"/>
              <p:nvPr/>
            </p:nvSpPr>
            <p:spPr>
              <a:xfrm>
                <a:off x="25653783" y="2876517"/>
                <a:ext cx="169463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proved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2C79529F-F1A9-5631-CC76-B8010EDE929A}"/>
                  </a:ext>
                </a:extLst>
              </p:cNvPr>
              <p:cNvSpPr txBox="1"/>
              <p:nvPr/>
            </p:nvSpPr>
            <p:spPr>
              <a:xfrm>
                <a:off x="14489444" y="2886771"/>
                <a:ext cx="148309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ybea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693B0F77-3E88-C60C-8FBD-73123C862480}"/>
                  </a:ext>
                </a:extLst>
              </p:cNvPr>
              <p:cNvSpPr txBox="1"/>
              <p:nvPr/>
            </p:nvSpPr>
            <p:spPr>
              <a:xfrm>
                <a:off x="20204770" y="2947731"/>
                <a:ext cx="165942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drace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2ED4DFAA-2A0F-BB86-A9B1-BFED94393B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t="32580"/>
            <a:stretch/>
          </p:blipFill>
          <p:spPr>
            <a:xfrm>
              <a:off x="10467033" y="7472127"/>
              <a:ext cx="19718147" cy="12788217"/>
            </a:xfrm>
            <a:prstGeom prst="rect">
              <a:avLst/>
            </a:prstGeom>
          </p:spPr>
        </p:pic>
      </p:grpSp>
      <p:sp>
        <p:nvSpPr>
          <p:cNvPr id="24" name="文本框 23">
            <a:extLst>
              <a:ext uri="{FF2B5EF4-FFF2-40B4-BE49-F238E27FC236}">
                <a16:creationId xmlns:a16="http://schemas.microsoft.com/office/drawing/2014/main" id="{33A4C922-2885-D65D-568E-D2FF17C744EF}"/>
              </a:ext>
            </a:extLst>
          </p:cNvPr>
          <p:cNvSpPr txBox="1"/>
          <p:nvPr/>
        </p:nvSpPr>
        <p:spPr>
          <a:xfrm>
            <a:off x="7253616" y="812472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542F342-BE0E-A7D5-EA7A-B97374DBD7BE}"/>
              </a:ext>
            </a:extLst>
          </p:cNvPr>
          <p:cNvSpPr txBox="1"/>
          <p:nvPr/>
        </p:nvSpPr>
        <p:spPr>
          <a:xfrm>
            <a:off x="7158098" y="6124397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E14EDE8-875B-5EC6-E3F4-A2343E665C21}"/>
              </a:ext>
            </a:extLst>
          </p:cNvPr>
          <p:cNvSpPr txBox="1"/>
          <p:nvPr/>
        </p:nvSpPr>
        <p:spPr>
          <a:xfrm>
            <a:off x="7169605" y="8508629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313B587-8EBC-BB21-5E6F-E41161E271EB}"/>
              </a:ext>
            </a:extLst>
          </p:cNvPr>
          <p:cNvSpPr txBox="1"/>
          <p:nvPr/>
        </p:nvSpPr>
        <p:spPr>
          <a:xfrm>
            <a:off x="26188746" y="14728430"/>
            <a:ext cx="15142134" cy="22198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304800" algn="ctr">
              <a:lnSpc>
                <a:spcPct val="150000"/>
              </a:lnSpc>
            </a:pPr>
            <a:r>
              <a:rPr lang="en-US" altLang="zh-CN" sz="3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1. SNP site analysis of </a:t>
            </a:r>
            <a:r>
              <a:rPr lang="en-US" altLang="zh-CN" sz="3200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9b. 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: Evolutionary distribution of </a:t>
            </a:r>
            <a:r>
              <a:rPr lang="en-US" altLang="zh-CN" sz="3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9b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B/C: SNP site analysis of </a:t>
            </a:r>
            <a:r>
              <a:rPr lang="en-US" altLang="zh-CN" sz="3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9b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3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indent="304800" algn="ctr">
              <a:lnSpc>
                <a:spcPct val="150000"/>
              </a:lnSpc>
            </a:pPr>
            <a:endParaRPr lang="zh-CN" altLang="zh-CN" sz="3200" b="1" i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4212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3B11CBEF-1EF6-5D9C-FFE7-94FF4409B38C}"/>
              </a:ext>
            </a:extLst>
          </p:cNvPr>
          <p:cNvGrpSpPr/>
          <p:nvPr/>
        </p:nvGrpSpPr>
        <p:grpSpPr>
          <a:xfrm>
            <a:off x="5925952" y="0"/>
            <a:ext cx="20142313" cy="21358297"/>
            <a:chOff x="10733926" y="0"/>
            <a:chExt cx="20142313" cy="21358297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6A8F4F9D-F647-5D36-AD07-71F1FB5925DF}"/>
                </a:ext>
              </a:extLst>
            </p:cNvPr>
            <p:cNvGrpSpPr/>
            <p:nvPr/>
          </p:nvGrpSpPr>
          <p:grpSpPr>
            <a:xfrm>
              <a:off x="10733926" y="0"/>
              <a:ext cx="19574515" cy="9546557"/>
              <a:chOff x="22255366" y="-15289"/>
              <a:chExt cx="19574515" cy="9546557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3AC27F9A-AFEF-2A6E-D64F-0346AF71B9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255366" y="0"/>
                <a:ext cx="8254931" cy="6672175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AFF3E9A6-B7B5-E217-6092-394E545F164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110882" y="104018"/>
                <a:ext cx="8107323" cy="6552868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FE854CDA-721E-81A3-2278-4166F17D61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574951" y="-15289"/>
                <a:ext cx="8254930" cy="6672175"/>
              </a:xfrm>
              <a:prstGeom prst="rect">
                <a:avLst/>
              </a:prstGeom>
            </p:spPr>
          </p:pic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35E24141-2CBF-FE93-6BF0-205E30443698}"/>
                  </a:ext>
                </a:extLst>
              </p:cNvPr>
              <p:cNvSpPr txBox="1"/>
              <p:nvPr/>
            </p:nvSpPr>
            <p:spPr>
              <a:xfrm>
                <a:off x="37214009" y="3613260"/>
                <a:ext cx="1694631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mproved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BA7E050D-3E1B-68A3-52B8-AF1D25F9EF5B}"/>
                  </a:ext>
                </a:extLst>
              </p:cNvPr>
              <p:cNvSpPr txBox="1"/>
              <p:nvPr/>
            </p:nvSpPr>
            <p:spPr>
              <a:xfrm>
                <a:off x="26049670" y="3623514"/>
                <a:ext cx="1483098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oybea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0496ED06-EFE9-1886-CE76-DD67A7DAA652}"/>
                  </a:ext>
                </a:extLst>
              </p:cNvPr>
              <p:cNvSpPr txBox="1"/>
              <p:nvPr/>
            </p:nvSpPr>
            <p:spPr>
              <a:xfrm>
                <a:off x="31764996" y="3684474"/>
                <a:ext cx="1659429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ndrace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031470BA-D11B-990D-7107-3BBFB5F41F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853945" y="7072541"/>
                <a:ext cx="17323657" cy="2458727"/>
              </a:xfrm>
              <a:prstGeom prst="rect">
                <a:avLst/>
              </a:prstGeom>
            </p:spPr>
          </p:pic>
          <p:sp>
            <p:nvSpPr>
              <p:cNvPr id="14" name="左大括号 13">
                <a:extLst>
                  <a:ext uri="{FF2B5EF4-FFF2-40B4-BE49-F238E27FC236}">
                    <a16:creationId xmlns:a16="http://schemas.microsoft.com/office/drawing/2014/main" id="{6FE543E5-D13C-8B1E-7C73-25F591D9954A}"/>
                  </a:ext>
                </a:extLst>
              </p:cNvPr>
              <p:cNvSpPr/>
              <p:nvPr/>
            </p:nvSpPr>
            <p:spPr>
              <a:xfrm rot="5400000">
                <a:off x="26929806" y="4742799"/>
                <a:ext cx="309810" cy="6562797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7F5A63E6-CB48-577D-19B6-BFFADF240808}"/>
                  </a:ext>
                </a:extLst>
              </p:cNvPr>
              <p:cNvSpPr txBox="1"/>
              <p:nvPr/>
            </p:nvSpPr>
            <p:spPr>
              <a:xfrm>
                <a:off x="26424135" y="7455326"/>
                <a:ext cx="138211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2890bp</a:t>
                </a:r>
                <a:endParaRPr lang="zh-CN" altLang="en-US" sz="2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左大括号 15">
                <a:extLst>
                  <a:ext uri="{FF2B5EF4-FFF2-40B4-BE49-F238E27FC236}">
                    <a16:creationId xmlns:a16="http://schemas.microsoft.com/office/drawing/2014/main" id="{C523EAF6-435D-7B34-512C-1CDE0C426705}"/>
                  </a:ext>
                </a:extLst>
              </p:cNvPr>
              <p:cNvSpPr/>
              <p:nvPr/>
            </p:nvSpPr>
            <p:spPr>
              <a:xfrm rot="5400000">
                <a:off x="39674931" y="6766997"/>
                <a:ext cx="309811" cy="2422964"/>
              </a:xfrm>
              <a:prstGeom prst="leftBrac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D9582A27-CCE1-3F2B-D41B-5CFE62B67169}"/>
                  </a:ext>
                </a:extLst>
              </p:cNvPr>
              <p:cNvSpPr txBox="1"/>
              <p:nvPr/>
            </p:nvSpPr>
            <p:spPr>
              <a:xfrm>
                <a:off x="39115245" y="7409605"/>
                <a:ext cx="1555907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39bp</a:t>
                </a:r>
                <a:endParaRPr lang="zh-CN" altLang="en-US" sz="2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43F695FB-D367-829E-C82A-557B3B3FB0A7}"/>
                  </a:ext>
                </a:extLst>
              </p:cNvPr>
              <p:cNvSpPr/>
              <p:nvPr/>
            </p:nvSpPr>
            <p:spPr>
              <a:xfrm>
                <a:off x="32411544" y="7490944"/>
                <a:ext cx="816578" cy="174366"/>
              </a:xfrm>
              <a:prstGeom prst="rect">
                <a:avLst/>
              </a:prstGeom>
              <a:solidFill>
                <a:srgbClr val="845FAF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2800"/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0599ECC1-8FC8-B3EA-2C65-C099DE9B8FFE}"/>
                  </a:ext>
                </a:extLst>
              </p:cNvPr>
              <p:cNvSpPr txBox="1"/>
              <p:nvPr/>
            </p:nvSpPr>
            <p:spPr>
              <a:xfrm>
                <a:off x="33277583" y="7306835"/>
                <a:ext cx="2226515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o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3E744B33-515D-0FD3-6CA4-81E3831F7CB8}"/>
                  </a:ext>
                </a:extLst>
              </p:cNvPr>
              <p:cNvSpPr txBox="1"/>
              <p:nvPr/>
            </p:nvSpPr>
            <p:spPr>
              <a:xfrm>
                <a:off x="34946914" y="7306840"/>
                <a:ext cx="2742287" cy="523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8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tron</a:t>
                </a:r>
                <a:endParaRPr lang="zh-CN" altLang="en-US" sz="28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8BA46583-7B07-2AE1-34F9-5F50CD64C05E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260722" y="7605971"/>
                <a:ext cx="736384" cy="4837"/>
              </a:xfrm>
              <a:prstGeom prst="line">
                <a:avLst/>
              </a:prstGeom>
              <a:ln w="25400">
                <a:solidFill>
                  <a:srgbClr val="A1BBE9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8824D7CB-021A-478A-9676-0C943492D6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</a:blip>
            <a:srcRect t="33813"/>
            <a:stretch/>
          </p:blipFill>
          <p:spPr>
            <a:xfrm>
              <a:off x="10972800" y="9269588"/>
              <a:ext cx="19903439" cy="12088709"/>
            </a:xfrm>
            <a:prstGeom prst="rect">
              <a:avLst/>
            </a:prstGeom>
          </p:spPr>
        </p:pic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730697AC-B034-FDA9-7420-155A3DEFDED7}"/>
              </a:ext>
            </a:extLst>
          </p:cNvPr>
          <p:cNvSpPr txBox="1"/>
          <p:nvPr/>
        </p:nvSpPr>
        <p:spPr>
          <a:xfrm>
            <a:off x="6906190" y="745588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B6C8AE6-B464-E25C-672A-8752E2FC186E}"/>
              </a:ext>
            </a:extLst>
          </p:cNvPr>
          <p:cNvSpPr txBox="1"/>
          <p:nvPr/>
        </p:nvSpPr>
        <p:spPr>
          <a:xfrm>
            <a:off x="6744562" y="6706442"/>
            <a:ext cx="49244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3291170-6E90-8F6D-BA9C-E96A840E34B6}"/>
              </a:ext>
            </a:extLst>
          </p:cNvPr>
          <p:cNvSpPr txBox="1"/>
          <p:nvPr/>
        </p:nvSpPr>
        <p:spPr>
          <a:xfrm>
            <a:off x="6756069" y="9090674"/>
            <a:ext cx="51809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3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206B53A-479E-0100-0942-39982290F32D}"/>
              </a:ext>
            </a:extLst>
          </p:cNvPr>
          <p:cNvSpPr txBox="1"/>
          <p:nvPr/>
        </p:nvSpPr>
        <p:spPr>
          <a:xfrm>
            <a:off x="25274346" y="14610443"/>
            <a:ext cx="15142134" cy="22198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indent="304800" algn="ctr">
              <a:lnSpc>
                <a:spcPct val="150000"/>
              </a:lnSpc>
            </a:pPr>
            <a:r>
              <a:rPr lang="en-US" altLang="zh-CN" sz="3200" b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ure S2. SNP site analysis of </a:t>
            </a:r>
            <a:r>
              <a:rPr lang="en-US" altLang="zh-CN" sz="3200" b="1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2a. 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: Evolutionary distribution of </a:t>
            </a:r>
            <a:r>
              <a:rPr lang="en-US" altLang="zh-CN" sz="3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2a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; B/C: SNP site analysis of </a:t>
            </a:r>
            <a:r>
              <a:rPr lang="en-US" altLang="zh-CN" sz="3200" i="1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mARF2a</a:t>
            </a:r>
            <a:r>
              <a:rPr lang="en-US" altLang="zh-CN" sz="32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3200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indent="304800" algn="ctr">
              <a:lnSpc>
                <a:spcPct val="150000"/>
              </a:lnSpc>
            </a:pPr>
            <a:endParaRPr lang="zh-CN" altLang="zh-CN" sz="3200" b="1" i="1" kern="1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3184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11</TotalTime>
  <Words>76</Words>
  <Application>Microsoft Office PowerPoint</Application>
  <PresentationFormat>Custom</PresentationFormat>
  <Paragraphs>2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461711448@qq.com</dc:creator>
  <cp:lastModifiedBy>MDPI</cp:lastModifiedBy>
  <cp:revision>4</cp:revision>
  <dcterms:created xsi:type="dcterms:W3CDTF">2025-04-08T15:57:27Z</dcterms:created>
  <dcterms:modified xsi:type="dcterms:W3CDTF">2025-05-09T11:59:19Z</dcterms:modified>
</cp:coreProperties>
</file>